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ryn" initials="K" lastIdx="1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78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608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3168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17689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67913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6615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590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007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017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919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782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440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384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B80DC8-BABC-452E-8CD7-6F5234E079B3}" type="datetimeFigureOut">
              <a:rPr lang="en-US" smtClean="0"/>
              <a:pPr/>
              <a:t>1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A230A-10AA-4D70-8FD4-514C027596C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8326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7450" y="281354"/>
            <a:ext cx="4379118" cy="269484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7450" y="3154799"/>
            <a:ext cx="4519610" cy="278129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12420" y="940266"/>
            <a:ext cx="20497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eld response Lr.IT</a:t>
            </a:r>
          </a:p>
          <a:p>
            <a:r>
              <a:rPr lang="en-US" b="1" dirty="0" smtClean="0"/>
              <a:t>30% variation explained by markers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12420" y="3898946"/>
            <a:ext cx="214503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eld severity </a:t>
            </a:r>
            <a:r>
              <a:rPr lang="en-US" b="1" dirty="0" err="1" smtClean="0"/>
              <a:t>Lr.SEV</a:t>
            </a:r>
            <a:endParaRPr lang="en-US" b="1" dirty="0" smtClean="0"/>
          </a:p>
          <a:p>
            <a:r>
              <a:rPr lang="en-US" b="1" dirty="0" smtClean="0"/>
              <a:t>26% variation explained by markers</a:t>
            </a:r>
            <a:endParaRPr lang="en-US" b="1" dirty="0"/>
          </a:p>
        </p:txBody>
      </p:sp>
      <p:sp>
        <p:nvSpPr>
          <p:cNvPr id="9" name="Rectangle 8"/>
          <p:cNvSpPr/>
          <p:nvPr/>
        </p:nvSpPr>
        <p:spPr>
          <a:xfrm>
            <a:off x="1905000" y="6022024"/>
            <a:ext cx="5242560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15000"/>
              </a:lnSpc>
              <a:spcAft>
                <a:spcPts val="600"/>
              </a:spcAft>
            </a:pPr>
            <a:r>
              <a:rPr lang="en-US" sz="1200" b="1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l Fig. S4</a:t>
            </a: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Scatterplots of fitted versus observed values based on the genotype of most significant 10 loci for </a:t>
            </a:r>
            <a:r>
              <a:rPr lang="en-US" sz="1200" dirty="0" err="1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Lr.SEV</a:t>
            </a:r>
            <a:r>
              <a:rPr lang="en-US" sz="12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and Lr.IT traits</a:t>
            </a:r>
            <a:endParaRPr lang="en-US" sz="1200" dirty="0">
              <a:effectLst/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23297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445</TotalTime>
  <Words>42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enome Wide Association Study (GWAS) of Leaf rust resistance in world wide wheat breeding lines</dc:title>
  <dc:creator>lgao</dc:creator>
  <cp:lastModifiedBy>lgao</cp:lastModifiedBy>
  <cp:revision>238</cp:revision>
  <dcterms:created xsi:type="dcterms:W3CDTF">2015-03-13T17:33:15Z</dcterms:created>
  <dcterms:modified xsi:type="dcterms:W3CDTF">2016-01-14T21:26:14Z</dcterms:modified>
</cp:coreProperties>
</file>